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9" r:id="rId3"/>
    <p:sldId id="270" r:id="rId4"/>
    <p:sldId id="271" r:id="rId5"/>
    <p:sldId id="272" r:id="rId6"/>
    <p:sldId id="27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8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EFFFE-D815-A114-4528-380AB6A16B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B86A8B-6426-BBAE-94EA-F9D074DAD6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D94E5A-E835-1375-857E-CFD082D61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727E54-D4BE-5CC4-E7EC-7F410F766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B757B9-0DF2-7FBB-C555-A8B49EB3C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483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54B1D2-2983-65CA-A86E-83EBE8B364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E3AFF3-F446-AA34-0C75-0B47B7F3B4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90F77F-797E-FC25-1066-B8F3F2B74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DAD4B9-2000-294C-3198-2F70D5E18F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9EFD49-5BEA-0594-67F6-AFC34B094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199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076B6B-1E92-5814-37AF-37FF61625E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2CACA0-5263-3131-E90A-8E382C75BF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5CA778-3C6A-7A89-4EF5-2C974B7061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187C1E-475A-163A-5A98-B4B4D1D13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2CDB8F-09FB-FA50-0D3A-53C1FF325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8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A0E361-B266-01D1-7041-C30A13B90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9BAB85-A269-7288-3FA4-BA402976FD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AE3501-087D-0385-4C39-D3685E755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3714AF-4300-7C5A-B305-97D9AD726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BB504C-B65E-EA27-8B77-D018B4D2B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59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4DB483-BE51-DD58-1775-15FDA8292E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54E90C-052C-D720-CF0C-27C4B85687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55F46-1F19-08ED-E596-1290C8C0F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F2CEDC-8605-CED2-473E-8EE8F8034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E4FCD9-5ECF-0821-1C67-E8ABCE1A3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761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8C8262-F99B-CE48-2539-0AFC11BE9C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00850B-73C7-4C7E-2C36-C296CA78D6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F9241A-AFE4-EF6B-1538-A473917CC5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77C6E5-45DC-B3B4-B0B4-EB5E37127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238A9B-923E-8256-5D47-303683D4B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033011-6A14-FD45-5953-710755E9A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700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085C68-B891-6631-4800-35A83E36D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EC7FD1-457D-07E5-BD2A-5541B2821F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E1443E-3BA4-3A56-12EA-24AC44493B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4E2D12-E223-7DAC-7EF5-1919E2B540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3864CF-FD8B-DA6B-4CAB-1D4FCD4F42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7B9DA0-6090-55E5-5DD1-793A33207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18550E-F70E-A9EE-EEC7-D397E5EE5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9AE067-8348-FD16-B47A-CC56EB826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982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668342-F46E-268F-A0EC-28910EEDD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3988FF-083C-3E49-7983-2E54653F7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D5CABA-F0F9-9627-EDBF-EEC65310C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3309EE3-B978-B898-E77F-8CD195976C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249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D719C1-96B5-6CD2-4543-2CF890EBD9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A2A354-8379-AE9A-05F3-6A0BA9E8A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C94610-FCF5-2494-796E-E36BF0559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371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10AAB5-E5CB-6F4E-3918-DD18D2C2C0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E189AD-4826-E06B-FD25-63AC4E5D19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51C8CB-21AA-BD74-C262-5B4D69028B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5D86B7-1CA2-ABC8-9F87-DE79B0486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C65208-9629-44AB-B7C6-55CDC54B1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62548B-4548-087E-F082-EA79BF647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247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11E04E-8ACF-088B-7872-6D36C8FE18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DD2499-9CC8-8DCA-6328-3D2532A10A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CEB734-FCCA-D0D2-92CB-D4D133828A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8BC735-3929-55E4-EB1B-152660F24B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09881C-0042-8CD1-040F-4A59E945D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416072-1920-6065-FF9E-6C555BB03C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042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B6AB170-63F0-5EAF-E299-7A6246FCD4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EDD38C-63B5-8CA9-04A3-BE13B4E4C5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D28E6C-4817-38AF-7792-7F4DE3A962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AC908-18D9-4837-B0B7-A2459A31F1CA}" type="datetimeFigureOut">
              <a:rPr lang="en-US" smtClean="0"/>
              <a:t>6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7E7B5A-0AD1-7988-5F7B-36535355C4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810653-F23A-1EC5-201E-488DF0119F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677D2-2B80-4E80-B881-DD59CE0F7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087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87794F0-E99C-279F-BC85-79052AE9D07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3424" y="593407"/>
            <a:ext cx="5217455" cy="3718344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D3641FB-4E8B-D8CE-2939-33E7D14C8865}"/>
              </a:ext>
            </a:extLst>
          </p:cNvPr>
          <p:cNvSpPr txBox="1"/>
          <p:nvPr/>
        </p:nvSpPr>
        <p:spPr>
          <a:xfrm>
            <a:off x="1483112" y="4554701"/>
            <a:ext cx="7602343" cy="17098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6a Testicular MDA value in PND 90 male offspring treated with Cd and PREOG. Values expressed in mean ± SD. Superscripts (a &amp; b) indicate a notable difference from the control and cadmium groups. Abbreviations: Cd; CdCL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xt; PREOG, MDA; malondialdehyde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75365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DCFCF8A-DCBC-5E9F-169C-EFEAE610735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0400" y="809901"/>
            <a:ext cx="4588417" cy="3233811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7EB2DAA-A4FC-E030-3E93-0E1F8AC06CE5}"/>
              </a:ext>
            </a:extLst>
          </p:cNvPr>
          <p:cNvSpPr txBox="1"/>
          <p:nvPr/>
        </p:nvSpPr>
        <p:spPr>
          <a:xfrm>
            <a:off x="1217341" y="4317769"/>
            <a:ext cx="9757317" cy="12943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6b Testicular H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lue in PND 90 offspring treated with Cd and PREOG. Values expressed in mean ± SD. Superscripts (a &amp; b) indicate a notable difference from the control and cadmium groups. Abbreviations: Cd; CdCL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xt; PREOG, H2O2; hydrogen peroxide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87605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883E242-6F19-1AA5-237A-528C45F65AA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2995" y="386304"/>
            <a:ext cx="5795924" cy="397605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65FAB7C-E613-0EC3-8739-12F67C566781}"/>
              </a:ext>
            </a:extLst>
          </p:cNvPr>
          <p:cNvSpPr txBox="1"/>
          <p:nvPr/>
        </p:nvSpPr>
        <p:spPr>
          <a:xfrm>
            <a:off x="1773043" y="4938317"/>
            <a:ext cx="9210907" cy="1027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6c. Testicular GSH value in PND 90 offspring treated with Cd and PREOG. Values expressed in mean ± SD. Superscripts (a &amp; b) indicate a notable difference from the control and cadmium groups. Abbreviations: Cd; CdCL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xt; PREOG, GSH; reduced glutathione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04187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6598774-75CD-F39A-F7F8-E4A4BB23691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76293" y="375517"/>
            <a:ext cx="5302482" cy="3637521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57A2B23-96A9-CCC4-ABA7-06292D3DAE07}"/>
              </a:ext>
            </a:extLst>
          </p:cNvPr>
          <p:cNvSpPr txBox="1"/>
          <p:nvPr/>
        </p:nvSpPr>
        <p:spPr>
          <a:xfrm>
            <a:off x="1137423" y="4841876"/>
            <a:ext cx="9623503" cy="12943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6d. Testicular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Px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lue in PND 90 offspring treated with Cd and PREOG. Values expressed in mean ± SD. Superscripts (a &amp; b) indicate a notable difference from the control and cadmium groups. Abbreviations: Cd; CdCL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xt; PREOG,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Px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glutathione peroxidase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79185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0DA6A5C-2BB1-045B-8020-1DFA6207F9A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2771" y="521698"/>
            <a:ext cx="6144708" cy="430322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EC0675C-C02F-82C0-652F-1B6706749D72}"/>
              </a:ext>
            </a:extLst>
          </p:cNvPr>
          <p:cNvSpPr txBox="1"/>
          <p:nvPr/>
        </p:nvSpPr>
        <p:spPr>
          <a:xfrm>
            <a:off x="1072375" y="4919934"/>
            <a:ext cx="9668107" cy="12943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6e Testicular GST value in PND 90 offspring treated with Cd and PREOG. Values expressed in mean ± SD. Superscripts (a &amp; b) indicate a notable difference from the control and cadmium groups. Abbreviations: Cd; CdCL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xt; PREOG, GST; glutathione-S- transferase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0098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3F650C1-DF07-1543-5BBF-1B2FD1CD1E7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5863" y="307106"/>
            <a:ext cx="6177388" cy="4237491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1841EAF-09BC-C676-F86B-98A666EE5EEF}"/>
              </a:ext>
            </a:extLst>
          </p:cNvPr>
          <p:cNvSpPr txBox="1"/>
          <p:nvPr/>
        </p:nvSpPr>
        <p:spPr>
          <a:xfrm>
            <a:off x="735980" y="5057553"/>
            <a:ext cx="10917043" cy="12943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6f. Testicular SOD value in PND 90 male offspring treated with Cd and PREOG. Values expressed in mean ± SD. Superscripts (a &amp; b) indicate a notable difference from the control and cadmium groups. Abbreviations: Cd; CdCL</a:t>
            </a:r>
            <a:r>
              <a:rPr lang="en-US" sz="1800" kern="1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xt; PREOG, SOD; superoxide dismutase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2398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28</Words>
  <Application>Microsoft Office PowerPoint</Application>
  <PresentationFormat>Widescreen</PresentationFormat>
  <Paragraphs>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kokide Joseph</dc:creator>
  <cp:lastModifiedBy>Ikokide Joseph</cp:lastModifiedBy>
  <cp:revision>1</cp:revision>
  <dcterms:created xsi:type="dcterms:W3CDTF">2025-06-19T05:20:59Z</dcterms:created>
  <dcterms:modified xsi:type="dcterms:W3CDTF">2025-06-19T05:23:52Z</dcterms:modified>
</cp:coreProperties>
</file>